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D07DA8-7569-4EC3-9744-2DA35F512E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4633D3-9682-439E-8F4C-2BFB033F36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DB084-FED8-4D71-B10D-66A4BC3BC3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BD6C8B-7C5C-4F54-9D79-2C75DDA01F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23AD46-DB39-43EE-BFED-0DD84C79EC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BCF74-B9A0-4EB8-9E3E-DF5662F3F9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2A18A-3AAC-4722-99F5-F727A15F0D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515AEE-754E-4C34-AC9D-ED85ABA8BC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57527-EFB1-4516-A71E-19F17CBC27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812C0B-AD38-4DAD-825D-0AA5CA98B0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BDA588-9E1D-4CC2-9602-4A2566B3C1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20E22E-E65E-4E25-9C45-13EFAB26E8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36D074-B09F-4F06-9132-3F3C0040AA2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79"/>
          <p:cNvSpPr/>
          <p:nvPr/>
        </p:nvSpPr>
        <p:spPr>
          <a:xfrm>
            <a:off x="142920" y="7383600"/>
            <a:ext cx="6508800" cy="2378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igure S6. Proposed response of central carbon metabolism during CCM induction in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N. oceanica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IMET1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,3PG, 1,3-biphosphoglycerate; 2OG, α-ketoglutarate; 2PG, 2-phosphoglycerate; 3PG, 3-phosphoglycerate; AAT, ADP/ATP transporter; ACS, acetyl-CoA synthetase; ACT, aconitate; AHD, aconitate hydratase; ALDO, fructose-1,6-bisphosphate aldolase; CS, ATP citrate synthase; DHAP, dihydroxyacetone phosphate; ENL, enolase; ENR, enoyl-ACP reductase; F1,6P, fructose 1,6-biphosphate; FBP, fructose bisphosphatase; F6P, fructose-6-phosphate; FHD, fumarate hydratase; FUM, fumarate; G6P, glucose-6-phosphate; GK, glucose kinase; Glu, glucose; GPDH, glyceraldehyde-3-phosphate dehydrogenase; GPI, glucose phosphate isomerase; GS, 1,3-β-glucan synthase; HAD, hydroxyacyl-ACP dehydrogenase; ICDH, isocitrate dehydrogenase; ICIT, isocitrate; MHD, malate dehydrogenase; NTT, nucleotide transporter; OGDH, 2-oxoglutarate dehydrogenase; PGAM, phosphoglycerate mutase; PGK, phosphoglycerate kinase; PFK, phosphofructose kinase; PPDK, phosphate dikinase; PPT, Pi/PEP translocator; PYR, pyruvate; SCS, succinyl-CoA synthetase; SDH, succinate dehydrogenase; SUC, succinyl-CoA; TPI, triosephosphate isomerase; SFC, succinate/fumarate carrier; FBPA: fructose-1,6-bisphosphate aldolase; TL: transketolase; SBP: sedoheptulose-bisphosphatase; RPI: Ribose-5-phosphate isomerase; RPE: Ribulose-phosphate 3-epimerase. The metabolites up- or down-regulated based on the metabolomics analysis are indicated by red arrow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组合 1"/>
          <p:cNvGrpSpPr/>
          <p:nvPr/>
        </p:nvGrpSpPr>
        <p:grpSpPr>
          <a:xfrm>
            <a:off x="907920" y="182520"/>
            <a:ext cx="5081760" cy="7272360"/>
            <a:chOff x="907920" y="182520"/>
            <a:chExt cx="5081760" cy="7272360"/>
          </a:xfrm>
        </p:grpSpPr>
        <p:pic>
          <p:nvPicPr>
            <p:cNvPr id="43" name="图片 1" descr=""/>
            <p:cNvPicPr/>
            <p:nvPr/>
          </p:nvPicPr>
          <p:blipFill>
            <a:blip r:embed="rId1"/>
            <a:stretch/>
          </p:blipFill>
          <p:spPr>
            <a:xfrm>
              <a:off x="1157040" y="182520"/>
              <a:ext cx="4832640" cy="4608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图片 2" descr=""/>
            <p:cNvPicPr/>
            <p:nvPr/>
          </p:nvPicPr>
          <p:blipFill>
            <a:blip r:embed="rId2"/>
            <a:stretch/>
          </p:blipFill>
          <p:spPr>
            <a:xfrm>
              <a:off x="907920" y="4791240"/>
              <a:ext cx="4902480" cy="26636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6T02:16:16Z</dcterms:created>
  <dc:creator>weili</dc:creator>
  <dc:description/>
  <dc:language>en-US</dc:language>
  <cp:lastModifiedBy>Srividya S</cp:lastModifiedBy>
  <dcterms:modified xsi:type="dcterms:W3CDTF">2019-06-19T13:48:23Z</dcterms:modified>
  <cp:revision>535</cp:revision>
  <dc:subject/>
  <dc:title>Main figure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5184</vt:lpwstr>
  </property>
</Properties>
</file>